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65" r:id="rId3"/>
    <p:sldId id="257" r:id="rId4"/>
    <p:sldId id="258" r:id="rId5"/>
    <p:sldId id="259" r:id="rId6"/>
    <p:sldId id="260" r:id="rId7"/>
    <p:sldId id="261" r:id="rId8"/>
    <p:sldId id="262" r:id="rId9"/>
    <p:sldId id="264" r:id="rId10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7006" autoAdjust="0"/>
    <p:restoredTop sz="94660"/>
  </p:normalViewPr>
  <p:slideViewPr>
    <p:cSldViewPr snapToGrid="0" showGuides="1">
      <p:cViewPr varScale="1">
        <p:scale>
          <a:sx n="95" d="100"/>
          <a:sy n="95" d="100"/>
        </p:scale>
        <p:origin x="58" y="82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presProps" Target="presProps.xml"/><Relationship Id="rId5" Type="http://schemas.openxmlformats.org/officeDocument/2006/relationships/slide" Target="slides/slide4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952EEA7-C092-4679-96B2-1A45BF6E7A17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088FEFD3-E81E-4F06-9F8C-603EA9C04DD9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92E8729-2AF3-48F0-95DD-45F86F611F2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93DCDA-BCD0-4A6F-9578-B96D5EAA7702}" type="datetimeFigureOut">
              <a:rPr lang="en-US" smtClean="0"/>
              <a:t>4/4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A3386F3-2629-41B8-A8ED-1E1D764A9C6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E99F902-FAB7-4C0B-B034-3A367B27EBC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D60929-2024-4A85-9601-DCC5DCADA38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9674273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61393D8-C365-4F57-BC49-638FEEEB9C9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901B49E5-CAE3-4D7C-8762-A53B1633537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8B8F255-A5B9-4BFC-89F9-8A8CEF2B568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93DCDA-BCD0-4A6F-9578-B96D5EAA7702}" type="datetimeFigureOut">
              <a:rPr lang="en-US" smtClean="0"/>
              <a:t>4/4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545EBD3-7170-4355-8D4B-7F091616E65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B12DE76-3D83-4D5F-9D25-613BF40FA19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D60929-2024-4A85-9601-DCC5DCADA38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7504159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859AD80D-358C-4B7E-80BA-C5B287CB6056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B480AA34-F4D2-467D-A100-0D5A150A951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61BACBE-4567-4DA5-ABCC-096165FA2F3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93DCDA-BCD0-4A6F-9578-B96D5EAA7702}" type="datetimeFigureOut">
              <a:rPr lang="en-US" smtClean="0"/>
              <a:t>4/4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134CF2B-36D6-493F-AB00-1447B785DD2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1302A08-7D01-4880-B2DF-3C5D87BFBAA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D60929-2024-4A85-9601-DCC5DCADA38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3262906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BE7776D-FF57-4172-8C23-3F57B7548E4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F851945-083F-4CED-BCC3-1A8A6CB8F680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2699A8F-B6CC-4E93-BB55-1874B4576F4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93DCDA-BCD0-4A6F-9578-B96D5EAA7702}" type="datetimeFigureOut">
              <a:rPr lang="en-US" smtClean="0"/>
              <a:t>4/4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D45A869-E711-47EA-864D-FA35CD14A0B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4F08914-6B73-44FA-B263-2BFB3175253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D60929-2024-4A85-9601-DCC5DCADA38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5476393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2D92F4F-1352-46D6-A51B-645B6070174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EA35D11-A027-4AB6-8F71-AC27ADC56F5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E9F49DE-8FB3-4577-B8D7-ECA942EEC7F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93DCDA-BCD0-4A6F-9578-B96D5EAA7702}" type="datetimeFigureOut">
              <a:rPr lang="en-US" smtClean="0"/>
              <a:t>4/4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C6A1CCD-C118-4612-87FB-8105A23A783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10557FF-BFA3-4675-B026-F5DF5CBE28A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D60929-2024-4A85-9601-DCC5DCADA38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3235432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59A2C16-0665-49D8-8A37-9AB2C9E1E29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3B2E08F-518D-4977-935C-6F6B03E49CA4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AAAB5E0A-06D7-41C6-95FE-A26DFA39191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D0083DF-FE18-4522-A5A3-FE4E27CCF4E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93DCDA-BCD0-4A6F-9578-B96D5EAA7702}" type="datetimeFigureOut">
              <a:rPr lang="en-US" smtClean="0"/>
              <a:t>4/4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92D79BB-EF70-4AB1-AB14-BEE9B176007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DD52974-D439-457E-9F5D-E5D78B312FD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D60929-2024-4A85-9601-DCC5DCADA38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7458825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9B49A4D-5533-45A8-A77E-DC9A34E1B02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6558D9F-2535-482C-BCCE-C451A7F1F70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14851EB4-6DA7-4764-B3FE-29BC9898C8C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AE5A33BA-F6EB-4BB5-827B-672E04AB28DB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D3ED456B-EE5C-4C49-A245-B17FE87D5C20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2DE4EC66-F8B0-4885-AD64-36B1FB23B66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93DCDA-BCD0-4A6F-9578-B96D5EAA7702}" type="datetimeFigureOut">
              <a:rPr lang="en-US" smtClean="0"/>
              <a:t>4/4/2022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8848CF10-3C37-4E85-9509-6CAA1FD227E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21009CF2-0D30-4249-A256-FB1F4A9DB26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D60929-2024-4A85-9601-DCC5DCADA38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3888602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2D5430F-3E65-4D3E-83BD-E245DEBCDF7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A1E28665-CA1E-40C0-BAFA-80DD374A340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93DCDA-BCD0-4A6F-9578-B96D5EAA7702}" type="datetimeFigureOut">
              <a:rPr lang="en-US" smtClean="0"/>
              <a:t>4/4/2022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E40A397B-EFCC-469C-B5F7-263238600D8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3A9B74F5-B7C2-4A80-A057-15EA43E2822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D60929-2024-4A85-9601-DCC5DCADA38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0256768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17982446-ECFE-45AE-93FC-158EE9F14B2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93DCDA-BCD0-4A6F-9578-B96D5EAA7702}" type="datetimeFigureOut">
              <a:rPr lang="en-US" smtClean="0"/>
              <a:t>4/4/2022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52B25EE1-5362-46BF-B1BE-93ACA10B8E7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798B6064-3E92-4705-A58C-03BF4F0E459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D60929-2024-4A85-9601-DCC5DCADA38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6264910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F5DD939-0172-445D-A142-DF985FEE01D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7010122-A00D-400A-AEA7-5117F2C5A2CB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12A38AE8-9998-4B32-B63E-1A338A1EB64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DD09E193-9981-497B-A79B-360E4B9E9BA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93DCDA-BCD0-4A6F-9578-B96D5EAA7702}" type="datetimeFigureOut">
              <a:rPr lang="en-US" smtClean="0"/>
              <a:t>4/4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321DAA4-847C-4031-AE7D-35AC3A4CD5B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B5D9B2F-0C83-4761-9F1E-8FB028897E1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D60929-2024-4A85-9601-DCC5DCADA38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1492348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936E67C-D623-4A86-9F8D-C933A436847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03414708-4020-415F-9B58-C07701D065CA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8C1BED27-EF3F-4663-90BD-EAC86B4AD47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E0B4A04-1344-4C77-B5F7-99AE073568C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93DCDA-BCD0-4A6F-9578-B96D5EAA7702}" type="datetimeFigureOut">
              <a:rPr lang="en-US" smtClean="0"/>
              <a:t>4/4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BDA6726-C1B6-4AE1-8D31-B72F7D5A44C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E79FF08-62F4-491A-B04E-D0207F809B5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D60929-2024-4A85-9601-DCC5DCADA38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4534484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BE7E8520-2584-42F4-B4B1-B41E5A7259D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73B9C7B-87AE-4CEA-99DD-7F58A88C4FC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3D8A138-1704-4C13-BC54-BB424826C858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93DCDA-BCD0-4A6F-9578-B96D5EAA7702}" type="datetimeFigureOut">
              <a:rPr lang="en-US" smtClean="0"/>
              <a:t>4/4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3E27A87-F576-4E55-81AE-C392055C39BA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FF2F083-6348-4374-B9AE-CCF6B1D17950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0D60929-2024-4A85-9601-DCC5DCADA38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4306418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tiff"/><Relationship Id="rId2" Type="http://schemas.openxmlformats.org/officeDocument/2006/relationships/image" Target="../media/image2.tiff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tiff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tiff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tiff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tiff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tiff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tiff"/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.tif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 descr="Diagram, schematic&#10;&#10;Description automatically generated">
            <a:extLst>
              <a:ext uri="{FF2B5EF4-FFF2-40B4-BE49-F238E27FC236}">
                <a16:creationId xmlns:a16="http://schemas.microsoft.com/office/drawing/2014/main" id="{01D0310F-48F9-45AD-BF8A-EF3E45CDCF75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92500" y="256513"/>
            <a:ext cx="3304032" cy="6272784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82EC44CB-9C49-4B8E-B81C-3A34C33CDD47}"/>
              </a:ext>
            </a:extLst>
          </p:cNvPr>
          <p:cNvSpPr txBox="1"/>
          <p:nvPr/>
        </p:nvSpPr>
        <p:spPr>
          <a:xfrm>
            <a:off x="8824395" y="686163"/>
            <a:ext cx="2554705" cy="203132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dirty="0"/>
              <a:t>Anti-GST antibody was from Invitrogen(A5800; 1:5,000 dilution) and peroxidase-conjugated goat anti-rabbit IgG was from Sigma (A0545; 1:5,000 dilution)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5B05C080-1C5A-4D72-A834-DEFF993762D9}"/>
              </a:ext>
            </a:extLst>
          </p:cNvPr>
          <p:cNvSpPr txBox="1"/>
          <p:nvPr/>
        </p:nvSpPr>
        <p:spPr>
          <a:xfrm>
            <a:off x="855639" y="1652155"/>
            <a:ext cx="77028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250 kDa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119DAB1C-5BBB-4EBB-82FB-0E5A9879C35D}"/>
              </a:ext>
            </a:extLst>
          </p:cNvPr>
          <p:cNvSpPr txBox="1"/>
          <p:nvPr/>
        </p:nvSpPr>
        <p:spPr>
          <a:xfrm>
            <a:off x="855639" y="2031321"/>
            <a:ext cx="77028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150 kDa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71F43804-4363-44AF-87F6-01A6DB726544}"/>
              </a:ext>
            </a:extLst>
          </p:cNvPr>
          <p:cNvSpPr txBox="1"/>
          <p:nvPr/>
        </p:nvSpPr>
        <p:spPr>
          <a:xfrm>
            <a:off x="855639" y="2350749"/>
            <a:ext cx="77028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100 kDa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CD392076-8490-44F4-B276-BE130271C1C6}"/>
              </a:ext>
            </a:extLst>
          </p:cNvPr>
          <p:cNvSpPr txBox="1"/>
          <p:nvPr/>
        </p:nvSpPr>
        <p:spPr>
          <a:xfrm>
            <a:off x="855639" y="2594287"/>
            <a:ext cx="77028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  75 kDa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DAB823A8-D4CD-4AA1-B691-AD1DD5AC561F}"/>
              </a:ext>
            </a:extLst>
          </p:cNvPr>
          <p:cNvSpPr txBox="1"/>
          <p:nvPr/>
        </p:nvSpPr>
        <p:spPr>
          <a:xfrm>
            <a:off x="855639" y="2921416"/>
            <a:ext cx="77028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  50 kDa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43F49E3B-493F-44A7-A42C-53B0DC6D2D61}"/>
              </a:ext>
            </a:extLst>
          </p:cNvPr>
          <p:cNvSpPr txBox="1"/>
          <p:nvPr/>
        </p:nvSpPr>
        <p:spPr>
          <a:xfrm>
            <a:off x="855639" y="3192439"/>
            <a:ext cx="77028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  37 kDa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7763F400-A7EC-4565-A2BC-BC30BFEBC099}"/>
              </a:ext>
            </a:extLst>
          </p:cNvPr>
          <p:cNvSpPr txBox="1"/>
          <p:nvPr/>
        </p:nvSpPr>
        <p:spPr>
          <a:xfrm>
            <a:off x="879702" y="4475563"/>
            <a:ext cx="77028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250 kDa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4C3FB214-2C50-464A-95BA-DA6509D56F58}"/>
              </a:ext>
            </a:extLst>
          </p:cNvPr>
          <p:cNvSpPr txBox="1"/>
          <p:nvPr/>
        </p:nvSpPr>
        <p:spPr>
          <a:xfrm>
            <a:off x="879702" y="4854729"/>
            <a:ext cx="77028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150 kDa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4D631430-16FF-4E23-AD3F-5944A120103C}"/>
              </a:ext>
            </a:extLst>
          </p:cNvPr>
          <p:cNvSpPr txBox="1"/>
          <p:nvPr/>
        </p:nvSpPr>
        <p:spPr>
          <a:xfrm>
            <a:off x="879702" y="5174157"/>
            <a:ext cx="77028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100 kDa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051B95BB-3954-421A-BCA8-391A8DFF44CC}"/>
              </a:ext>
            </a:extLst>
          </p:cNvPr>
          <p:cNvSpPr txBox="1"/>
          <p:nvPr/>
        </p:nvSpPr>
        <p:spPr>
          <a:xfrm>
            <a:off x="879702" y="5417695"/>
            <a:ext cx="77028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  75 kDa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F4634BEB-B97B-4688-AE41-E995EADFBC3A}"/>
              </a:ext>
            </a:extLst>
          </p:cNvPr>
          <p:cNvSpPr txBox="1"/>
          <p:nvPr/>
        </p:nvSpPr>
        <p:spPr>
          <a:xfrm>
            <a:off x="879702" y="5744824"/>
            <a:ext cx="77028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  50 kDa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63A4C63C-BB96-434B-A41B-8647B6C077E7}"/>
              </a:ext>
            </a:extLst>
          </p:cNvPr>
          <p:cNvSpPr txBox="1"/>
          <p:nvPr/>
        </p:nvSpPr>
        <p:spPr>
          <a:xfrm>
            <a:off x="879702" y="6015847"/>
            <a:ext cx="77028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  37 kDa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B90F0A76-8438-4CA7-BFB9-85ED4420CEF0}"/>
              </a:ext>
            </a:extLst>
          </p:cNvPr>
          <p:cNvSpPr txBox="1"/>
          <p:nvPr/>
        </p:nvSpPr>
        <p:spPr>
          <a:xfrm rot="18576158">
            <a:off x="1791967" y="3772596"/>
            <a:ext cx="171951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Fig 9c and d SLBR</a:t>
            </a:r>
            <a:r>
              <a:rPr lang="en-US" sz="1200" baseline="-25000" dirty="0"/>
              <a:t>SK678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FBAE18CA-E14C-49CE-90D1-AFE2F75C6489}"/>
              </a:ext>
            </a:extLst>
          </p:cNvPr>
          <p:cNvSpPr txBox="1"/>
          <p:nvPr/>
        </p:nvSpPr>
        <p:spPr>
          <a:xfrm rot="18576158">
            <a:off x="2676113" y="3861006"/>
            <a:ext cx="141427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Fig 9d SLBR</a:t>
            </a:r>
            <a:r>
              <a:rPr lang="en-US" sz="1200" baseline="-25000" dirty="0"/>
              <a:t>SK678</a:t>
            </a:r>
            <a:r>
              <a:rPr lang="en-US" sz="1200" baseline="30000" dirty="0"/>
              <a:t>E298R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044DA8B7-186E-4816-87FF-0FC018A21651}"/>
              </a:ext>
            </a:extLst>
          </p:cNvPr>
          <p:cNvSpPr txBox="1"/>
          <p:nvPr/>
        </p:nvSpPr>
        <p:spPr>
          <a:xfrm rot="19557762">
            <a:off x="3070510" y="617845"/>
            <a:ext cx="169475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Fig 9c SLBR</a:t>
            </a:r>
            <a:r>
              <a:rPr lang="en-US" sz="1200" baseline="-25000" dirty="0"/>
              <a:t>UB10712</a:t>
            </a:r>
            <a:r>
              <a:rPr lang="en-US" sz="1200" baseline="30000" dirty="0"/>
              <a:t>Hsa-loops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3BDAAF81-7F3D-43F9-99E6-2B3F4A17CB0E}"/>
              </a:ext>
            </a:extLst>
          </p:cNvPr>
          <p:cNvSpPr txBox="1"/>
          <p:nvPr/>
        </p:nvSpPr>
        <p:spPr>
          <a:xfrm rot="19557762">
            <a:off x="3599328" y="3554750"/>
            <a:ext cx="169475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Fig 9c SLBR</a:t>
            </a:r>
            <a:r>
              <a:rPr lang="en-US" sz="1200" baseline="-25000" dirty="0"/>
              <a:t>SK678</a:t>
            </a:r>
            <a:r>
              <a:rPr lang="en-US" sz="1200" baseline="30000" dirty="0"/>
              <a:t>Hsa-loops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B55F9314-DBD4-4FF0-AA7B-193E276D8897}"/>
              </a:ext>
            </a:extLst>
          </p:cNvPr>
          <p:cNvSpPr txBox="1"/>
          <p:nvPr/>
        </p:nvSpPr>
        <p:spPr>
          <a:xfrm rot="19557762">
            <a:off x="4041218" y="803592"/>
            <a:ext cx="103106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Fig 9c SLBR</a:t>
            </a:r>
            <a:r>
              <a:rPr lang="en-US" sz="1200" baseline="-25000" dirty="0"/>
              <a:t>Hsa</a:t>
            </a:r>
            <a:endParaRPr lang="en-US" sz="1200" baseline="30000" dirty="0"/>
          </a:p>
        </p:txBody>
      </p:sp>
      <p:cxnSp>
        <p:nvCxnSpPr>
          <p:cNvPr id="3" name="Straight Connector 2">
            <a:extLst>
              <a:ext uri="{FF2B5EF4-FFF2-40B4-BE49-F238E27FC236}">
                <a16:creationId xmlns:a16="http://schemas.microsoft.com/office/drawing/2014/main" id="{E09707B5-7E59-41C2-AF62-91488637314E}"/>
              </a:ext>
            </a:extLst>
          </p:cNvPr>
          <p:cNvCxnSpPr/>
          <p:nvPr/>
        </p:nvCxnSpPr>
        <p:spPr>
          <a:xfrm>
            <a:off x="2103967" y="4632630"/>
            <a:ext cx="393700" cy="0"/>
          </a:xfrm>
          <a:prstGeom prst="line">
            <a:avLst/>
          </a:prstGeom>
          <a:ln w="1270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8" name="Straight Connector 27">
            <a:extLst>
              <a:ext uri="{FF2B5EF4-FFF2-40B4-BE49-F238E27FC236}">
                <a16:creationId xmlns:a16="http://schemas.microsoft.com/office/drawing/2014/main" id="{40DD6703-E5FA-4A6E-8C1B-3476DEBE6782}"/>
              </a:ext>
            </a:extLst>
          </p:cNvPr>
          <p:cNvCxnSpPr/>
          <p:nvPr/>
        </p:nvCxnSpPr>
        <p:spPr>
          <a:xfrm>
            <a:off x="2933700" y="4624164"/>
            <a:ext cx="393700" cy="0"/>
          </a:xfrm>
          <a:prstGeom prst="line">
            <a:avLst/>
          </a:prstGeom>
          <a:ln w="1270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9" name="Straight Connector 28">
            <a:extLst>
              <a:ext uri="{FF2B5EF4-FFF2-40B4-BE49-F238E27FC236}">
                <a16:creationId xmlns:a16="http://schemas.microsoft.com/office/drawing/2014/main" id="{DC55E060-414C-43AB-8404-324D45EBD238}"/>
              </a:ext>
            </a:extLst>
          </p:cNvPr>
          <p:cNvCxnSpPr/>
          <p:nvPr/>
        </p:nvCxnSpPr>
        <p:spPr>
          <a:xfrm>
            <a:off x="3810000" y="4158497"/>
            <a:ext cx="393700" cy="0"/>
          </a:xfrm>
          <a:prstGeom prst="line">
            <a:avLst/>
          </a:prstGeom>
          <a:ln w="1270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0" name="Straight Connector 29">
            <a:extLst>
              <a:ext uri="{FF2B5EF4-FFF2-40B4-BE49-F238E27FC236}">
                <a16:creationId xmlns:a16="http://schemas.microsoft.com/office/drawing/2014/main" id="{87D303C3-FE0B-4334-BDCF-81888559DA91}"/>
              </a:ext>
            </a:extLst>
          </p:cNvPr>
          <p:cNvCxnSpPr/>
          <p:nvPr/>
        </p:nvCxnSpPr>
        <p:spPr>
          <a:xfrm>
            <a:off x="4186766" y="1313697"/>
            <a:ext cx="393700" cy="0"/>
          </a:xfrm>
          <a:prstGeom prst="line">
            <a:avLst/>
          </a:prstGeom>
          <a:ln w="1270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1" name="Straight Connector 30">
            <a:extLst>
              <a:ext uri="{FF2B5EF4-FFF2-40B4-BE49-F238E27FC236}">
                <a16:creationId xmlns:a16="http://schemas.microsoft.com/office/drawing/2014/main" id="{73FF1488-47A5-40E1-AC0C-B2FA6B701EB6}"/>
              </a:ext>
            </a:extLst>
          </p:cNvPr>
          <p:cNvCxnSpPr/>
          <p:nvPr/>
        </p:nvCxnSpPr>
        <p:spPr>
          <a:xfrm>
            <a:off x="3268133" y="1250197"/>
            <a:ext cx="393700" cy="0"/>
          </a:xfrm>
          <a:prstGeom prst="line">
            <a:avLst/>
          </a:prstGeom>
          <a:ln w="1270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2" name="TextBox 31">
            <a:extLst>
              <a:ext uri="{FF2B5EF4-FFF2-40B4-BE49-F238E27FC236}">
                <a16:creationId xmlns:a16="http://schemas.microsoft.com/office/drawing/2014/main" id="{64CE01E7-AA92-42AE-98DB-F733C2280FDB}"/>
              </a:ext>
            </a:extLst>
          </p:cNvPr>
          <p:cNvSpPr txBox="1"/>
          <p:nvPr/>
        </p:nvSpPr>
        <p:spPr>
          <a:xfrm>
            <a:off x="6243279" y="1160756"/>
            <a:ext cx="210151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Fig. 9c-d</a:t>
            </a:r>
            <a:endParaRPr lang="en-US" baseline="-25000" dirty="0"/>
          </a:p>
        </p:txBody>
      </p:sp>
    </p:spTree>
    <p:extLst>
      <p:ext uri="{BB962C8B-B14F-4D97-AF65-F5344CB8AC3E}">
        <p14:creationId xmlns:p14="http://schemas.microsoft.com/office/powerpoint/2010/main" val="36735969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 descr="A picture containing text&#10;&#10;Description automatically generated">
            <a:extLst>
              <a:ext uri="{FF2B5EF4-FFF2-40B4-BE49-F238E27FC236}">
                <a16:creationId xmlns:a16="http://schemas.microsoft.com/office/drawing/2014/main" id="{D0E3C74D-0055-45CB-89A2-B27C76BA3F0C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85097" y="350774"/>
            <a:ext cx="2801112" cy="6345936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82F54E54-420D-4300-9637-C3D10912690E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194313" y="792232"/>
            <a:ext cx="2731594" cy="2636768"/>
          </a:xfrm>
          <a:prstGeom prst="rect">
            <a:avLst/>
          </a:prstGeom>
        </p:spPr>
      </p:pic>
      <p:cxnSp>
        <p:nvCxnSpPr>
          <p:cNvPr id="9" name="Straight Arrow Connector 8">
            <a:extLst>
              <a:ext uri="{FF2B5EF4-FFF2-40B4-BE49-F238E27FC236}">
                <a16:creationId xmlns:a16="http://schemas.microsoft.com/office/drawing/2014/main" id="{09E1D9CF-5931-4292-9668-309822DD1A88}"/>
              </a:ext>
            </a:extLst>
          </p:cNvPr>
          <p:cNvCxnSpPr>
            <a:cxnSpLocks/>
          </p:cNvCxnSpPr>
          <p:nvPr/>
        </p:nvCxnSpPr>
        <p:spPr>
          <a:xfrm>
            <a:off x="5723021" y="792232"/>
            <a:ext cx="32084" cy="880157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" name="TextBox 9">
            <a:extLst>
              <a:ext uri="{FF2B5EF4-FFF2-40B4-BE49-F238E27FC236}">
                <a16:creationId xmlns:a16="http://schemas.microsoft.com/office/drawing/2014/main" id="{3CA82284-ECDC-4E5E-9609-4539E36A3EEB}"/>
              </a:ext>
            </a:extLst>
          </p:cNvPr>
          <p:cNvSpPr txBox="1"/>
          <p:nvPr/>
        </p:nvSpPr>
        <p:spPr>
          <a:xfrm>
            <a:off x="5113421" y="530622"/>
            <a:ext cx="2249905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UB10712 binding pooled plasma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64678D8E-623D-4362-847D-85EC9EB3C8E6}"/>
              </a:ext>
            </a:extLst>
          </p:cNvPr>
          <p:cNvSpPr txBox="1"/>
          <p:nvPr/>
        </p:nvSpPr>
        <p:spPr>
          <a:xfrm>
            <a:off x="971848" y="874016"/>
            <a:ext cx="2249905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UB10712 binding pooled plasma</a:t>
            </a:r>
          </a:p>
        </p:txBody>
      </p:sp>
      <p:cxnSp>
        <p:nvCxnSpPr>
          <p:cNvPr id="13" name="Straight Arrow Connector 12">
            <a:extLst>
              <a:ext uri="{FF2B5EF4-FFF2-40B4-BE49-F238E27FC236}">
                <a16:creationId xmlns:a16="http://schemas.microsoft.com/office/drawing/2014/main" id="{923E5FA6-83D7-461D-92F8-91FF34637653}"/>
              </a:ext>
            </a:extLst>
          </p:cNvPr>
          <p:cNvCxnSpPr>
            <a:cxnSpLocks/>
          </p:cNvCxnSpPr>
          <p:nvPr/>
        </p:nvCxnSpPr>
        <p:spPr>
          <a:xfrm>
            <a:off x="1288679" y="1135626"/>
            <a:ext cx="0" cy="471084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" name="TextBox 15">
            <a:extLst>
              <a:ext uri="{FF2B5EF4-FFF2-40B4-BE49-F238E27FC236}">
                <a16:creationId xmlns:a16="http://schemas.microsoft.com/office/drawing/2014/main" id="{E26701A9-80D9-4046-924F-09BED520E7E1}"/>
              </a:ext>
            </a:extLst>
          </p:cNvPr>
          <p:cNvSpPr txBox="1"/>
          <p:nvPr/>
        </p:nvSpPr>
        <p:spPr>
          <a:xfrm>
            <a:off x="3288631" y="161290"/>
            <a:ext cx="210151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Fig. 9c SLBR</a:t>
            </a:r>
            <a:r>
              <a:rPr lang="en-US" baseline="-25000" dirty="0"/>
              <a:t>UB10712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A5A63345-1C95-4718-BB2F-F354B0333E45}"/>
              </a:ext>
            </a:extLst>
          </p:cNvPr>
          <p:cNvSpPr txBox="1"/>
          <p:nvPr/>
        </p:nvSpPr>
        <p:spPr>
          <a:xfrm>
            <a:off x="8824395" y="686163"/>
            <a:ext cx="2554705" cy="203132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dirty="0"/>
              <a:t>Anti-GST antibody was from Invitrogen(A5800; 1:5,000 dilution) and peroxidase-conjugated goat anti-rabbit IgG was from Sigma (A0545; 1:5,000 dilution)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283545A7-28A0-4BA5-9536-97830120353C}"/>
              </a:ext>
            </a:extLst>
          </p:cNvPr>
          <p:cNvSpPr txBox="1"/>
          <p:nvPr/>
        </p:nvSpPr>
        <p:spPr>
          <a:xfrm>
            <a:off x="139184" y="1518500"/>
            <a:ext cx="77028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250 kDa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D7C82CA5-3E73-407B-95FB-E0B5541F0E3C}"/>
              </a:ext>
            </a:extLst>
          </p:cNvPr>
          <p:cNvSpPr txBox="1"/>
          <p:nvPr/>
        </p:nvSpPr>
        <p:spPr>
          <a:xfrm>
            <a:off x="139184" y="1897666"/>
            <a:ext cx="77028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150 kDa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515422E8-1FDF-4E36-A65D-592789356BD5}"/>
              </a:ext>
            </a:extLst>
          </p:cNvPr>
          <p:cNvSpPr txBox="1"/>
          <p:nvPr/>
        </p:nvSpPr>
        <p:spPr>
          <a:xfrm>
            <a:off x="139184" y="2249180"/>
            <a:ext cx="77028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100 kDa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B384CE8B-9827-445F-854E-A13A1226CC1E}"/>
              </a:ext>
            </a:extLst>
          </p:cNvPr>
          <p:cNvSpPr txBox="1"/>
          <p:nvPr/>
        </p:nvSpPr>
        <p:spPr>
          <a:xfrm>
            <a:off x="139184" y="2504744"/>
            <a:ext cx="77028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  75 kDa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B5EBF158-A479-4065-95F6-612C77A38A52}"/>
              </a:ext>
            </a:extLst>
          </p:cNvPr>
          <p:cNvSpPr txBox="1"/>
          <p:nvPr/>
        </p:nvSpPr>
        <p:spPr>
          <a:xfrm>
            <a:off x="145965" y="2800488"/>
            <a:ext cx="77028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  50 kDa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6FD5E74F-051F-4FB3-BE93-686C23DA711F}"/>
              </a:ext>
            </a:extLst>
          </p:cNvPr>
          <p:cNvSpPr txBox="1"/>
          <p:nvPr/>
        </p:nvSpPr>
        <p:spPr>
          <a:xfrm>
            <a:off x="119044" y="3068085"/>
            <a:ext cx="77028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  37 kDa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11E5DA44-4891-49C3-910F-FE488F9F34E2}"/>
              </a:ext>
            </a:extLst>
          </p:cNvPr>
          <p:cNvSpPr txBox="1"/>
          <p:nvPr/>
        </p:nvSpPr>
        <p:spPr>
          <a:xfrm>
            <a:off x="3475199" y="1518500"/>
            <a:ext cx="77028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250 kDa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A9D1DB65-1119-4976-A7E9-D0CDDCA899D5}"/>
              </a:ext>
            </a:extLst>
          </p:cNvPr>
          <p:cNvSpPr txBox="1"/>
          <p:nvPr/>
        </p:nvSpPr>
        <p:spPr>
          <a:xfrm>
            <a:off x="3475199" y="1897666"/>
            <a:ext cx="77028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150 kDa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B88F1CF5-2329-46FA-AB37-5A416238E2D0}"/>
              </a:ext>
            </a:extLst>
          </p:cNvPr>
          <p:cNvSpPr txBox="1"/>
          <p:nvPr/>
        </p:nvSpPr>
        <p:spPr>
          <a:xfrm>
            <a:off x="3475199" y="2249180"/>
            <a:ext cx="77028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100 kDa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C0809F53-BE80-4E15-96B8-23A8FC520BD8}"/>
              </a:ext>
            </a:extLst>
          </p:cNvPr>
          <p:cNvSpPr txBox="1"/>
          <p:nvPr/>
        </p:nvSpPr>
        <p:spPr>
          <a:xfrm>
            <a:off x="3475199" y="2504744"/>
            <a:ext cx="77028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  75 kDa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0647FDE4-2DD4-4BFE-BFDE-1A96B8D8FA50}"/>
              </a:ext>
            </a:extLst>
          </p:cNvPr>
          <p:cNvSpPr txBox="1"/>
          <p:nvPr/>
        </p:nvSpPr>
        <p:spPr>
          <a:xfrm>
            <a:off x="3481980" y="2800488"/>
            <a:ext cx="77028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  50 kDa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7E3759D8-50F5-4A57-9384-56C3FC13BD68}"/>
              </a:ext>
            </a:extLst>
          </p:cNvPr>
          <p:cNvSpPr txBox="1"/>
          <p:nvPr/>
        </p:nvSpPr>
        <p:spPr>
          <a:xfrm>
            <a:off x="3455059" y="3068085"/>
            <a:ext cx="77028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  37 kDa</a:t>
            </a:r>
          </a:p>
        </p:txBody>
      </p:sp>
    </p:spTree>
    <p:extLst>
      <p:ext uri="{BB962C8B-B14F-4D97-AF65-F5344CB8AC3E}">
        <p14:creationId xmlns:p14="http://schemas.microsoft.com/office/powerpoint/2010/main" val="160940393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 descr="A picture containing diagram&#10;&#10;Description automatically generated">
            <a:extLst>
              <a:ext uri="{FF2B5EF4-FFF2-40B4-BE49-F238E27FC236}">
                <a16:creationId xmlns:a16="http://schemas.microsoft.com/office/drawing/2014/main" id="{D471BADC-6B21-4039-81A1-D4F7005068EC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6171" t="48519"/>
          <a:stretch/>
        </p:blipFill>
        <p:spPr>
          <a:xfrm>
            <a:off x="2081464" y="1608220"/>
            <a:ext cx="1540628" cy="2407041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3F047BF5-12A8-49EF-8522-65E99A7014B0}"/>
              </a:ext>
            </a:extLst>
          </p:cNvPr>
          <p:cNvSpPr txBox="1"/>
          <p:nvPr/>
        </p:nvSpPr>
        <p:spPr>
          <a:xfrm>
            <a:off x="1360965" y="2289829"/>
            <a:ext cx="77028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250 kDa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95858272-6CB4-436E-B97C-F3B4A8EEFCD5}"/>
              </a:ext>
            </a:extLst>
          </p:cNvPr>
          <p:cNvSpPr txBox="1"/>
          <p:nvPr/>
        </p:nvSpPr>
        <p:spPr>
          <a:xfrm>
            <a:off x="1360965" y="2668995"/>
            <a:ext cx="77028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150 kDa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7541D0BF-FB4A-4FA7-A2A4-3A4E4DB817A6}"/>
              </a:ext>
            </a:extLst>
          </p:cNvPr>
          <p:cNvSpPr txBox="1"/>
          <p:nvPr/>
        </p:nvSpPr>
        <p:spPr>
          <a:xfrm>
            <a:off x="1360965" y="3020509"/>
            <a:ext cx="77028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100 kDa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5A8C8D81-1FF1-4CFB-829D-5B061C3811ED}"/>
              </a:ext>
            </a:extLst>
          </p:cNvPr>
          <p:cNvSpPr txBox="1"/>
          <p:nvPr/>
        </p:nvSpPr>
        <p:spPr>
          <a:xfrm>
            <a:off x="1360965" y="3276073"/>
            <a:ext cx="77028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  75 kDa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EF98027F-A5A9-4227-B264-DC19FB7481AC}"/>
              </a:ext>
            </a:extLst>
          </p:cNvPr>
          <p:cNvSpPr txBox="1"/>
          <p:nvPr/>
        </p:nvSpPr>
        <p:spPr>
          <a:xfrm>
            <a:off x="1360965" y="3667374"/>
            <a:ext cx="77028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  50 kDa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4B2A9A07-37D8-4E08-84B6-2D03338C602E}"/>
              </a:ext>
            </a:extLst>
          </p:cNvPr>
          <p:cNvSpPr txBox="1"/>
          <p:nvPr/>
        </p:nvSpPr>
        <p:spPr>
          <a:xfrm>
            <a:off x="1796716" y="922421"/>
            <a:ext cx="210151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Fig. 9a SLBR</a:t>
            </a:r>
            <a:r>
              <a:rPr lang="en-US" baseline="-25000" dirty="0"/>
              <a:t>Hsa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4992A910-150E-4AA1-8B42-E1B2E21A18CA}"/>
              </a:ext>
            </a:extLst>
          </p:cNvPr>
          <p:cNvSpPr txBox="1"/>
          <p:nvPr/>
        </p:nvSpPr>
        <p:spPr>
          <a:xfrm>
            <a:off x="4765742" y="1291753"/>
            <a:ext cx="2554705" cy="203132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dirty="0"/>
              <a:t>Anti-GST antibody was from Invitrogen(A5800; 1:5,000 dilution) and peroxidase-conjugated goat anti-rabbit IgG was from Sigma (A0545; 1:5,000 dilution)</a:t>
            </a:r>
          </a:p>
        </p:txBody>
      </p:sp>
    </p:spTree>
    <p:extLst>
      <p:ext uri="{BB962C8B-B14F-4D97-AF65-F5344CB8AC3E}">
        <p14:creationId xmlns:p14="http://schemas.microsoft.com/office/powerpoint/2010/main" val="114648676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 descr="A picture containing text&#10;&#10;Description automatically generated">
            <a:extLst>
              <a:ext uri="{FF2B5EF4-FFF2-40B4-BE49-F238E27FC236}">
                <a16:creationId xmlns:a16="http://schemas.microsoft.com/office/drawing/2014/main" id="{2705F001-1A67-416B-8122-8AEE6A86CEEF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0000" r="-1"/>
          <a:stretch/>
        </p:blipFill>
        <p:spPr>
          <a:xfrm>
            <a:off x="1772478" y="1301960"/>
            <a:ext cx="1325880" cy="1789176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60D4A8CE-C6BF-4515-BC3C-99EFA6A170A0}"/>
              </a:ext>
            </a:extLst>
          </p:cNvPr>
          <p:cNvSpPr txBox="1"/>
          <p:nvPr/>
        </p:nvSpPr>
        <p:spPr>
          <a:xfrm>
            <a:off x="1056165" y="1812145"/>
            <a:ext cx="77028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250 kDa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7591A0D6-7CD2-461E-989A-92E87F75AC31}"/>
              </a:ext>
            </a:extLst>
          </p:cNvPr>
          <p:cNvSpPr txBox="1"/>
          <p:nvPr/>
        </p:nvSpPr>
        <p:spPr>
          <a:xfrm>
            <a:off x="1056165" y="2191311"/>
            <a:ext cx="77028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150 kDa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560EE572-C87F-4356-9BBA-F8A3A558EF9C}"/>
              </a:ext>
            </a:extLst>
          </p:cNvPr>
          <p:cNvSpPr txBox="1"/>
          <p:nvPr/>
        </p:nvSpPr>
        <p:spPr>
          <a:xfrm>
            <a:off x="1056165" y="2542825"/>
            <a:ext cx="77028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100 kDa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72C851FE-5B4F-4E0A-A6E6-DE48B98B1387}"/>
              </a:ext>
            </a:extLst>
          </p:cNvPr>
          <p:cNvSpPr txBox="1"/>
          <p:nvPr/>
        </p:nvSpPr>
        <p:spPr>
          <a:xfrm>
            <a:off x="1056165" y="2798389"/>
            <a:ext cx="77028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  75 kDa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1AA49A44-6CBF-4736-AD81-C7504764ED43}"/>
              </a:ext>
            </a:extLst>
          </p:cNvPr>
          <p:cNvSpPr txBox="1"/>
          <p:nvPr/>
        </p:nvSpPr>
        <p:spPr>
          <a:xfrm>
            <a:off x="1796716" y="922421"/>
            <a:ext cx="35693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Fig. 9a SLBR</a:t>
            </a:r>
            <a:r>
              <a:rPr lang="en-US" baseline="-25000" dirty="0"/>
              <a:t>SK678</a:t>
            </a:r>
            <a:r>
              <a:rPr lang="en-US" baseline="30000" dirty="0"/>
              <a:t>E298R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460EE4E0-F83C-4D2E-974A-B3A309E6522D}"/>
              </a:ext>
            </a:extLst>
          </p:cNvPr>
          <p:cNvSpPr txBox="1"/>
          <p:nvPr/>
        </p:nvSpPr>
        <p:spPr>
          <a:xfrm>
            <a:off x="4765742" y="1291753"/>
            <a:ext cx="2554705" cy="203132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dirty="0"/>
              <a:t>Anti-GST antibody was from Invitrogen(A5800; 1:5,000 dilution) and peroxidase-conjugated goat anti-rabbit IgG was from Sigma (A0545; 1:5,000 dilution)</a:t>
            </a:r>
          </a:p>
        </p:txBody>
      </p:sp>
    </p:spTree>
    <p:extLst>
      <p:ext uri="{BB962C8B-B14F-4D97-AF65-F5344CB8AC3E}">
        <p14:creationId xmlns:p14="http://schemas.microsoft.com/office/powerpoint/2010/main" val="4134564609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6049D444-19E4-4F0F-9651-116C40F60941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23807" y="1649931"/>
            <a:ext cx="1200912" cy="2194560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CB92F474-86C6-43F3-85FC-F498B24DA33D}"/>
              </a:ext>
            </a:extLst>
          </p:cNvPr>
          <p:cNvSpPr txBox="1"/>
          <p:nvPr/>
        </p:nvSpPr>
        <p:spPr>
          <a:xfrm>
            <a:off x="2167080" y="2189138"/>
            <a:ext cx="77028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250 kDa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C6F72872-CCCC-4BEC-95DE-C8F100E973FB}"/>
              </a:ext>
            </a:extLst>
          </p:cNvPr>
          <p:cNvSpPr txBox="1"/>
          <p:nvPr/>
        </p:nvSpPr>
        <p:spPr>
          <a:xfrm>
            <a:off x="2167080" y="2568304"/>
            <a:ext cx="77028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150 kDa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D4F859BB-6444-48A8-9391-1E3DEDFFB347}"/>
              </a:ext>
            </a:extLst>
          </p:cNvPr>
          <p:cNvSpPr txBox="1"/>
          <p:nvPr/>
        </p:nvSpPr>
        <p:spPr>
          <a:xfrm>
            <a:off x="2167080" y="2919818"/>
            <a:ext cx="77028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100 kDa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33DBC5CB-56D6-4144-9C60-A992ECD2BB15}"/>
              </a:ext>
            </a:extLst>
          </p:cNvPr>
          <p:cNvSpPr txBox="1"/>
          <p:nvPr/>
        </p:nvSpPr>
        <p:spPr>
          <a:xfrm>
            <a:off x="2167080" y="3175382"/>
            <a:ext cx="77028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75 kDa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2596CC27-7511-4334-9740-4152BF921B50}"/>
              </a:ext>
            </a:extLst>
          </p:cNvPr>
          <p:cNvSpPr txBox="1"/>
          <p:nvPr/>
        </p:nvSpPr>
        <p:spPr>
          <a:xfrm>
            <a:off x="2167080" y="3566683"/>
            <a:ext cx="77028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50 kDa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412D3F32-98E6-470C-A870-1C2B2249ADC9}"/>
              </a:ext>
            </a:extLst>
          </p:cNvPr>
          <p:cNvSpPr txBox="1"/>
          <p:nvPr/>
        </p:nvSpPr>
        <p:spPr>
          <a:xfrm>
            <a:off x="1796716" y="922421"/>
            <a:ext cx="312821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Fig. 9a SLBR</a:t>
            </a:r>
            <a:r>
              <a:rPr lang="en-US" baseline="-25000" dirty="0"/>
              <a:t>SK678</a:t>
            </a:r>
            <a:r>
              <a:rPr lang="en-US" baseline="30000" dirty="0"/>
              <a:t>Hsa-loops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5FF61478-ECB1-431B-873F-AB2197419CB5}"/>
              </a:ext>
            </a:extLst>
          </p:cNvPr>
          <p:cNvSpPr txBox="1"/>
          <p:nvPr/>
        </p:nvSpPr>
        <p:spPr>
          <a:xfrm>
            <a:off x="4765742" y="1291753"/>
            <a:ext cx="2554705" cy="203132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dirty="0"/>
              <a:t>Anti-GST antibody was from Invitrogen(A5800; 1:5,000 dilution) and peroxidase-conjugated goat anti-rabbit IgG was from Sigma (A0545; 1:5,000 dilution)</a:t>
            </a:r>
          </a:p>
        </p:txBody>
      </p:sp>
    </p:spTree>
    <p:extLst>
      <p:ext uri="{BB962C8B-B14F-4D97-AF65-F5344CB8AC3E}">
        <p14:creationId xmlns:p14="http://schemas.microsoft.com/office/powerpoint/2010/main" val="2459603756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 descr="A picture containing text&#10;&#10;Description automatically generated">
            <a:extLst>
              <a:ext uri="{FF2B5EF4-FFF2-40B4-BE49-F238E27FC236}">
                <a16:creationId xmlns:a16="http://schemas.microsoft.com/office/drawing/2014/main" id="{53517270-48DB-4ED7-9519-470C2BFAA5EA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63842" y="1373124"/>
            <a:ext cx="1371600" cy="2130552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39A3A6F7-D1FA-4351-972C-860776ED6CD1}"/>
              </a:ext>
            </a:extLst>
          </p:cNvPr>
          <p:cNvSpPr txBox="1"/>
          <p:nvPr/>
        </p:nvSpPr>
        <p:spPr>
          <a:xfrm>
            <a:off x="807512" y="1840222"/>
            <a:ext cx="77028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250 kDa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C506BB69-E410-4839-85B2-8A7C2D64F41C}"/>
              </a:ext>
            </a:extLst>
          </p:cNvPr>
          <p:cNvSpPr txBox="1"/>
          <p:nvPr/>
        </p:nvSpPr>
        <p:spPr>
          <a:xfrm>
            <a:off x="807512" y="2219388"/>
            <a:ext cx="77028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150 kDa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83010579-4CFA-4070-A10B-1800D34FF808}"/>
              </a:ext>
            </a:extLst>
          </p:cNvPr>
          <p:cNvSpPr txBox="1"/>
          <p:nvPr/>
        </p:nvSpPr>
        <p:spPr>
          <a:xfrm>
            <a:off x="807512" y="2570902"/>
            <a:ext cx="77028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100 kDa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2CEB27F7-00D0-41C5-8A6E-6A4F23855CDB}"/>
              </a:ext>
            </a:extLst>
          </p:cNvPr>
          <p:cNvSpPr txBox="1"/>
          <p:nvPr/>
        </p:nvSpPr>
        <p:spPr>
          <a:xfrm>
            <a:off x="807512" y="2826466"/>
            <a:ext cx="77028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  75 kDa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3F245E48-5896-48B0-B3E7-0C9131C62769}"/>
              </a:ext>
            </a:extLst>
          </p:cNvPr>
          <p:cNvSpPr txBox="1"/>
          <p:nvPr/>
        </p:nvSpPr>
        <p:spPr>
          <a:xfrm>
            <a:off x="807512" y="3217767"/>
            <a:ext cx="77028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  50 kDa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196513EE-DE28-4F6E-9B4B-83D10328AB22}"/>
              </a:ext>
            </a:extLst>
          </p:cNvPr>
          <p:cNvSpPr txBox="1"/>
          <p:nvPr/>
        </p:nvSpPr>
        <p:spPr>
          <a:xfrm>
            <a:off x="1796716" y="922421"/>
            <a:ext cx="235417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Fig. 9a SLBR</a:t>
            </a:r>
            <a:r>
              <a:rPr lang="en-US" baseline="-25000" dirty="0"/>
              <a:t>SK678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8F314639-43AE-4330-8A50-3FD2A20BDDF6}"/>
              </a:ext>
            </a:extLst>
          </p:cNvPr>
          <p:cNvSpPr txBox="1"/>
          <p:nvPr/>
        </p:nvSpPr>
        <p:spPr>
          <a:xfrm>
            <a:off x="4765742" y="1291753"/>
            <a:ext cx="2554705" cy="203132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dirty="0"/>
              <a:t>Anti-GST antibody was from Invitrogen(A5800; 1:5,000 dilution) and peroxidase-conjugated goat anti-rabbit IgG was from Sigma (A0545; 1:5,000 dilution)</a:t>
            </a:r>
          </a:p>
        </p:txBody>
      </p:sp>
    </p:spTree>
    <p:extLst>
      <p:ext uri="{BB962C8B-B14F-4D97-AF65-F5344CB8AC3E}">
        <p14:creationId xmlns:p14="http://schemas.microsoft.com/office/powerpoint/2010/main" val="2156484726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 descr="A picture containing text&#10;&#10;Description automatically generated">
            <a:extLst>
              <a:ext uri="{FF2B5EF4-FFF2-40B4-BE49-F238E27FC236}">
                <a16:creationId xmlns:a16="http://schemas.microsoft.com/office/drawing/2014/main" id="{CE2E65B8-FD73-4ADC-AFEE-3642C1295F2B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32367" y="1133295"/>
            <a:ext cx="1383792" cy="1856232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3E569BCE-5126-483D-A6BC-5A94E410E551}"/>
              </a:ext>
            </a:extLst>
          </p:cNvPr>
          <p:cNvSpPr txBox="1"/>
          <p:nvPr/>
        </p:nvSpPr>
        <p:spPr>
          <a:xfrm>
            <a:off x="2247291" y="1358959"/>
            <a:ext cx="77028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250 kDa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0352E6B4-1F16-4096-9500-6DB2D8A3A1FA}"/>
              </a:ext>
            </a:extLst>
          </p:cNvPr>
          <p:cNvSpPr txBox="1"/>
          <p:nvPr/>
        </p:nvSpPr>
        <p:spPr>
          <a:xfrm>
            <a:off x="2247291" y="1738125"/>
            <a:ext cx="77028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150 kDa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A1F51107-ED69-4390-BA86-4D9732EB2663}"/>
              </a:ext>
            </a:extLst>
          </p:cNvPr>
          <p:cNvSpPr txBox="1"/>
          <p:nvPr/>
        </p:nvSpPr>
        <p:spPr>
          <a:xfrm>
            <a:off x="2247291" y="2089639"/>
            <a:ext cx="77028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100 kDa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36E6607E-DFD2-411D-9C49-7D3EC1ABD621}"/>
              </a:ext>
            </a:extLst>
          </p:cNvPr>
          <p:cNvSpPr txBox="1"/>
          <p:nvPr/>
        </p:nvSpPr>
        <p:spPr>
          <a:xfrm>
            <a:off x="2247291" y="2401357"/>
            <a:ext cx="77028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  75 kDa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DF34C3AE-CC05-4DC0-A630-EFB494B99061}"/>
              </a:ext>
            </a:extLst>
          </p:cNvPr>
          <p:cNvSpPr txBox="1"/>
          <p:nvPr/>
        </p:nvSpPr>
        <p:spPr>
          <a:xfrm>
            <a:off x="2247291" y="2736504"/>
            <a:ext cx="77028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  50 kDa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221669F3-6714-432A-A904-7C0F6BF95CBC}"/>
              </a:ext>
            </a:extLst>
          </p:cNvPr>
          <p:cNvSpPr txBox="1"/>
          <p:nvPr/>
        </p:nvSpPr>
        <p:spPr>
          <a:xfrm>
            <a:off x="932367" y="651131"/>
            <a:ext cx="246908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Fig. 9a SLBR</a:t>
            </a:r>
            <a:r>
              <a:rPr lang="en-US" baseline="-25000" dirty="0"/>
              <a:t>UB10712</a:t>
            </a:r>
            <a:r>
              <a:rPr lang="en-US" baseline="30000" dirty="0"/>
              <a:t>E285R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0757C9CA-BF88-4AE3-AAD7-63D755B10E91}"/>
              </a:ext>
            </a:extLst>
          </p:cNvPr>
          <p:cNvSpPr txBox="1"/>
          <p:nvPr/>
        </p:nvSpPr>
        <p:spPr>
          <a:xfrm>
            <a:off x="4765742" y="1291753"/>
            <a:ext cx="2554705" cy="203132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dirty="0"/>
              <a:t>Anti-GST antibody was from Invitrogen(A5800; 1:5,000 dilution) and peroxidase-conjugated goat anti-rabbit IgG was from Sigma (A0545; 1:5,000 dilution)</a:t>
            </a:r>
          </a:p>
        </p:txBody>
      </p:sp>
    </p:spTree>
    <p:extLst>
      <p:ext uri="{BB962C8B-B14F-4D97-AF65-F5344CB8AC3E}">
        <p14:creationId xmlns:p14="http://schemas.microsoft.com/office/powerpoint/2010/main" val="3451380439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picture containing graphical user interface&#10;&#10;Description automatically generated">
            <a:extLst>
              <a:ext uri="{FF2B5EF4-FFF2-40B4-BE49-F238E27FC236}">
                <a16:creationId xmlns:a16="http://schemas.microsoft.com/office/drawing/2014/main" id="{58AE8C5F-0E29-4C1D-AD7A-7589BADBF71F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50000" b="58063"/>
          <a:stretch/>
        </p:blipFill>
        <p:spPr>
          <a:xfrm>
            <a:off x="1308154" y="869995"/>
            <a:ext cx="1431036" cy="1960827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F118C19F-AAD3-4140-83FC-C3E4CDA6872F}"/>
              </a:ext>
            </a:extLst>
          </p:cNvPr>
          <p:cNvSpPr txBox="1"/>
          <p:nvPr/>
        </p:nvSpPr>
        <p:spPr>
          <a:xfrm>
            <a:off x="635060" y="1022074"/>
            <a:ext cx="77028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250 kDa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690F58AE-B5C4-4502-8265-6BCF548622A3}"/>
              </a:ext>
            </a:extLst>
          </p:cNvPr>
          <p:cNvSpPr txBox="1"/>
          <p:nvPr/>
        </p:nvSpPr>
        <p:spPr>
          <a:xfrm>
            <a:off x="635060" y="1401240"/>
            <a:ext cx="77028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150 kDa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E9B63918-F3BD-49E9-BBA5-D7DCA9EA2C7B}"/>
              </a:ext>
            </a:extLst>
          </p:cNvPr>
          <p:cNvSpPr txBox="1"/>
          <p:nvPr/>
        </p:nvSpPr>
        <p:spPr>
          <a:xfrm>
            <a:off x="635060" y="1752754"/>
            <a:ext cx="77028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100 kDa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5380BA07-94AF-49C6-BEB7-CA4F2D5E9CBC}"/>
              </a:ext>
            </a:extLst>
          </p:cNvPr>
          <p:cNvSpPr txBox="1"/>
          <p:nvPr/>
        </p:nvSpPr>
        <p:spPr>
          <a:xfrm>
            <a:off x="635060" y="2008318"/>
            <a:ext cx="77028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  75 kDa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4D2CBDCB-CC37-4D90-A2BA-807EB68E01B4}"/>
              </a:ext>
            </a:extLst>
          </p:cNvPr>
          <p:cNvSpPr txBox="1"/>
          <p:nvPr/>
        </p:nvSpPr>
        <p:spPr>
          <a:xfrm>
            <a:off x="635060" y="2351487"/>
            <a:ext cx="77028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  50 kDa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09D20C61-59CF-429D-9A0A-2858C68FC429}"/>
              </a:ext>
            </a:extLst>
          </p:cNvPr>
          <p:cNvSpPr txBox="1"/>
          <p:nvPr/>
        </p:nvSpPr>
        <p:spPr>
          <a:xfrm>
            <a:off x="1439778" y="360947"/>
            <a:ext cx="363754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Fig. 9a SLBR</a:t>
            </a:r>
            <a:r>
              <a:rPr lang="en-US" baseline="-25000" dirty="0"/>
              <a:t>UB10712</a:t>
            </a:r>
            <a:r>
              <a:rPr lang="en-US" baseline="30000" dirty="0"/>
              <a:t>Hsa-loops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B90F355F-A42C-45F9-96AD-B54B009EBBE8}"/>
              </a:ext>
            </a:extLst>
          </p:cNvPr>
          <p:cNvSpPr txBox="1"/>
          <p:nvPr/>
        </p:nvSpPr>
        <p:spPr>
          <a:xfrm>
            <a:off x="4765742" y="1291753"/>
            <a:ext cx="2554705" cy="203132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dirty="0"/>
              <a:t>Anti-GST antibody was from Invitrogen(A5800; 1:5,000 dilution) and peroxidase-conjugated goat anti-rabbit IgG was from Sigma (A0545; 1:5,000 dilution)</a:t>
            </a:r>
          </a:p>
        </p:txBody>
      </p:sp>
    </p:spTree>
    <p:extLst>
      <p:ext uri="{BB962C8B-B14F-4D97-AF65-F5344CB8AC3E}">
        <p14:creationId xmlns:p14="http://schemas.microsoft.com/office/powerpoint/2010/main" val="4241915942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picture containing text, outdoor, day&#10;&#10;Description automatically generated">
            <a:extLst>
              <a:ext uri="{FF2B5EF4-FFF2-40B4-BE49-F238E27FC236}">
                <a16:creationId xmlns:a16="http://schemas.microsoft.com/office/drawing/2014/main" id="{7E16EF83-9CC2-42A2-B50C-BD528FC4704F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101596" y="1810115"/>
            <a:ext cx="1359408" cy="1856232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24D4C771-ADA5-46DC-82D3-AFC22813AC7A}"/>
              </a:ext>
            </a:extLst>
          </p:cNvPr>
          <p:cNvSpPr txBox="1"/>
          <p:nvPr/>
        </p:nvSpPr>
        <p:spPr>
          <a:xfrm>
            <a:off x="3406334" y="2001080"/>
            <a:ext cx="77028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250 kDa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4D7EF0B1-B3E7-454A-BEEF-EC7509163732}"/>
              </a:ext>
            </a:extLst>
          </p:cNvPr>
          <p:cNvSpPr txBox="1"/>
          <p:nvPr/>
        </p:nvSpPr>
        <p:spPr>
          <a:xfrm>
            <a:off x="3406334" y="2380246"/>
            <a:ext cx="77028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150 kDa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E17D1468-0981-4FBA-B005-63E422DB3394}"/>
              </a:ext>
            </a:extLst>
          </p:cNvPr>
          <p:cNvSpPr txBox="1"/>
          <p:nvPr/>
        </p:nvSpPr>
        <p:spPr>
          <a:xfrm>
            <a:off x="3406334" y="2731760"/>
            <a:ext cx="77028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100 kDa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C21743C4-7264-4651-9E77-5A3B9F3502A7}"/>
              </a:ext>
            </a:extLst>
          </p:cNvPr>
          <p:cNvSpPr txBox="1"/>
          <p:nvPr/>
        </p:nvSpPr>
        <p:spPr>
          <a:xfrm>
            <a:off x="3406334" y="3007379"/>
            <a:ext cx="77028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75 kDa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9647443A-2D04-45D6-8A96-1F2640C5CFE2}"/>
              </a:ext>
            </a:extLst>
          </p:cNvPr>
          <p:cNvSpPr txBox="1"/>
          <p:nvPr/>
        </p:nvSpPr>
        <p:spPr>
          <a:xfrm>
            <a:off x="3406334" y="3378625"/>
            <a:ext cx="77028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50 kDa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C9C2D7F3-18E9-4148-9273-AFDEDAB65F33}"/>
              </a:ext>
            </a:extLst>
          </p:cNvPr>
          <p:cNvSpPr txBox="1"/>
          <p:nvPr/>
        </p:nvSpPr>
        <p:spPr>
          <a:xfrm>
            <a:off x="1796716" y="922421"/>
            <a:ext cx="247048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Fig. 9a SLBR</a:t>
            </a:r>
            <a:r>
              <a:rPr lang="en-US" baseline="-25000" dirty="0"/>
              <a:t>UB10712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8EE8D999-F926-42A8-948D-93ADD9AFFFED}"/>
              </a:ext>
            </a:extLst>
          </p:cNvPr>
          <p:cNvSpPr txBox="1"/>
          <p:nvPr/>
        </p:nvSpPr>
        <p:spPr>
          <a:xfrm>
            <a:off x="4765742" y="1291753"/>
            <a:ext cx="2554705" cy="203132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dirty="0"/>
              <a:t>Anti-GST antibody was from Invitrogen(A5800; 1:5,000 dilution) and peroxidase-conjugated goat anti-rabbit IgG was from Sigma (A0545; 1:5,000 dilution)</a:t>
            </a:r>
          </a:p>
        </p:txBody>
      </p:sp>
    </p:spTree>
    <p:extLst>
      <p:ext uri="{BB962C8B-B14F-4D97-AF65-F5344CB8AC3E}">
        <p14:creationId xmlns:p14="http://schemas.microsoft.com/office/powerpoint/2010/main" val="2634081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50</TotalTime>
  <Words>422</Words>
  <Application>Microsoft Office PowerPoint</Application>
  <PresentationFormat>Widescreen</PresentationFormat>
  <Paragraphs>83</Paragraphs>
  <Slides>9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9</vt:i4>
      </vt:variant>
    </vt:vector>
  </HeadingPairs>
  <TitlesOfParts>
    <vt:vector size="13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Haley Stubbs</dc:creator>
  <cp:lastModifiedBy>Haley Stubbs</cp:lastModifiedBy>
  <cp:revision>36</cp:revision>
  <dcterms:created xsi:type="dcterms:W3CDTF">2022-03-31T16:58:46Z</dcterms:created>
  <dcterms:modified xsi:type="dcterms:W3CDTF">2022-04-04T14:49:52Z</dcterms:modified>
</cp:coreProperties>
</file>